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A Yejin(17KC1504)" initials="HY" lastIdx="4" clrIdx="0">
    <p:extLst>
      <p:ext uri="{19B8F6BF-5375-455C-9EA6-DF929625EA0E}">
        <p15:presenceInfo xmlns:p15="http://schemas.microsoft.com/office/powerpoint/2012/main" userId="S::17kc1504@meijigakuin.ac.jp::e966ce90-185c-4268-adaa-9f336083089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256" autoAdjust="0"/>
  </p:normalViewPr>
  <p:slideViewPr>
    <p:cSldViewPr snapToGrid="0" showGuides="1">
      <p:cViewPr varScale="1">
        <p:scale>
          <a:sx n="102" d="100"/>
          <a:sy n="102" d="100"/>
        </p:scale>
        <p:origin x="870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6E577DF-20C1-4F20-B844-76BFC358D5A7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08940CE3-BA0F-4322-A6BF-E65B82196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6554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940CE3-BA0F-4322-A6BF-E65B821969BD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86055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B57262-03F6-20A8-E7F8-DFBB565D0D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B459927-ADFF-243C-EE4C-5EAD190600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3A36D7-670C-5FB8-4B5C-56F2C3A49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CC1586-6F6D-8D76-8FE3-33509B167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286AE2-5320-AE1E-D8A2-C8787F285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646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2A6AEA-2645-D180-D97B-CBCE26C591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FE96F5-B83D-1EF3-2264-9CBCCA69DA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813A9F-31C2-CA20-FFE9-0C6B66847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D0676B-43D6-9A8B-3EE9-91563BFC3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5EC06E-18FA-4B49-18B0-7A3974B6B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752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F43A8E-F638-708C-CADF-622668EEE3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328F84-4BB9-6A39-27D4-D41381E9FA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4CF72-9451-22AF-DF76-F2D1AD790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1F1EC8-EC2F-6FF8-E5E5-2593B0747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26FC36-B1CE-6994-E596-239D04D0E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526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CCAF2F-DE3F-D7AE-0F0D-2405B72CA9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940B88-6FA1-0552-FB4F-E21858AF0A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DAA9ED-7A25-22A0-AD4C-1F689DD1F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C819DB-0065-83B5-82A9-4F99345EE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406956-91A4-69E2-F651-A64F7A971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12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07E5F8-15E5-6B94-B557-3E0AA8F341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DF9CEE-FB6C-6592-3754-FD266EB4E4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6EFDE2-F7A3-D10F-763C-0BA9B68CD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33CD27-AE00-49A6-E98B-3ABBD1C2AC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788DDD-3440-F8DD-14FD-B4B23D64A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59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455162-5364-CC8C-C51C-D93613E65B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6295EC-9B19-DAE1-9511-A4BC9B461D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13C6A8-5BE7-3D9A-90D6-E1A9241BEB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407FAA-3BF9-D622-F43C-0BEFBBBFE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7AA710-B955-1A5E-DD65-3E2A736DA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C338BB-5CE1-8AD3-D6BD-D7827E0DE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517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517A19-9483-D2B2-44EA-7F9E67E6DE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BB25F6-5ADA-9546-1D23-7FBAB30D4E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5A0A85-6ED9-6EE7-2E31-DD2B05A980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FA861C-4EC4-6600-B048-45E7638AAD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0373AC-D0D3-653F-A9C1-E40524D2F9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F2859B-A782-343C-38D1-583620771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3AEF918-658D-B558-962F-3C3F16462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53B054-BDFF-A7AA-A747-5A596663D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621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4ED174-B090-63BC-3380-575D6EB293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86DFDE-86E5-68C0-B5CA-9299F63E0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4D28CAB-D12C-0274-BD70-89F237DEE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501B5C-05C2-5D79-9E0C-ECCAC7ACE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371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3A31F02-017E-510D-69F9-303CC03DD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C2F8DB-F84E-F52E-AAA7-9FDA69769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ACA4257-826B-56FE-200B-CDFA2AA47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68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C2E8B6-B48E-A998-E165-94031EA9F0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059459-CDA9-5568-3A9B-4463A100A1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EA0DB0-69FC-C2A8-5374-0872E44AD3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305F75-F7C7-3032-F2FC-AE600F6AD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BB23B0-29CD-EEE0-AB95-1822826E42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F83594-ADF1-9232-003C-6164DB8D2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558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4C961-A220-FBBB-93BE-6499C9EB4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DEF11B-6D5D-AF94-4F10-808F7E086F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0197A2-29F7-1949-875F-B8C494E944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894EE8-E92E-26C4-E20D-A0E409410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0B9DEC-0E04-AD67-643B-8D9900056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5E5A20-4295-EFF9-0BDB-F897305870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941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5AD2CC2-93D9-6CC1-A477-190DE8F2D7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7D12AC-3B85-3323-3DE7-4A72C4A784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DD1218-B61C-BE16-693C-07810AF020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F18C4-6206-424C-85D3-3152D53DFB10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6D116F-115F-A809-EF0A-7715AD2CF3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349BC8-2A74-B7C1-BBF8-32E476DD7A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821D5-87EC-420A-BEFE-F857F50D9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333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68E2C5A-F3B8-B47F-45E9-30B1FF1D9B66}"/>
              </a:ext>
            </a:extLst>
          </p:cNvPr>
          <p:cNvGrpSpPr/>
          <p:nvPr/>
        </p:nvGrpSpPr>
        <p:grpSpPr>
          <a:xfrm>
            <a:off x="1171502" y="165100"/>
            <a:ext cx="9848995" cy="6256400"/>
            <a:chOff x="877259" y="0"/>
            <a:chExt cx="10356036" cy="6840600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7000F4D-7B2F-AFBC-4749-F00D42EFAEFB}"/>
                </a:ext>
              </a:extLst>
            </p:cNvPr>
            <p:cNvSpPr txBox="1"/>
            <p:nvPr/>
          </p:nvSpPr>
          <p:spPr>
            <a:xfrm>
              <a:off x="3582406" y="102640"/>
              <a:ext cx="3765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C657D17-3DD4-12A0-ED2A-92713BF6A873}"/>
                </a:ext>
              </a:extLst>
            </p:cNvPr>
            <p:cNvSpPr txBox="1"/>
            <p:nvPr/>
          </p:nvSpPr>
          <p:spPr>
            <a:xfrm>
              <a:off x="877259" y="3597985"/>
              <a:ext cx="3765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50351D6-834E-1747-5DCD-78E6FFC6150B}"/>
                </a:ext>
              </a:extLst>
            </p:cNvPr>
            <p:cNvSpPr txBox="1"/>
            <p:nvPr/>
          </p:nvSpPr>
          <p:spPr>
            <a:xfrm>
              <a:off x="6918108" y="3619914"/>
              <a:ext cx="3765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40CFC53-9BEE-1858-A9F5-5907C8562DC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58951" y="0"/>
              <a:ext cx="4274102" cy="359694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861AF0D-B069-D354-8805-3F31113FE40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95577" y="198135"/>
              <a:ext cx="1600423" cy="485843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72D810F-EE4A-B9E6-DD60-7E909CC137B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25550" y="3429000"/>
              <a:ext cx="3859350" cy="3377803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9D9E66AD-F1AF-CC0E-615D-C285EB962E9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12194" y="3615997"/>
              <a:ext cx="1638529" cy="457264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8374DDC4-E63F-9CC9-9F69-CA9EDCAE595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229599" y="3429000"/>
              <a:ext cx="4003696" cy="3411600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74440924-4893-B0DE-B3C5-D2A9AD7C858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736248" y="3607196"/>
              <a:ext cx="1695687" cy="476316"/>
            </a:xfrm>
            <a:prstGeom prst="rect">
              <a:avLst/>
            </a:prstGeom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A54C1D34-D9F6-0190-7A80-B01C3F41AA04}"/>
              </a:ext>
            </a:extLst>
          </p:cNvPr>
          <p:cNvSpPr txBox="1"/>
          <p:nvPr/>
        </p:nvSpPr>
        <p:spPr>
          <a:xfrm>
            <a:off x="2102270" y="6468221"/>
            <a:ext cx="962863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>
                <a:latin typeface="Times New Roman" panose="02020603050405020304" pitchFamily="18" charset="0"/>
                <a:ea typeface="바탕" panose="02030600000101010101" pitchFamily="18" charset="-127"/>
                <a:cs typeface="¹ÙÅÁ"/>
              </a:rPr>
              <a:t>Supplementary Material </a:t>
            </a:r>
            <a:r>
              <a:rPr lang="en-US" sz="1100" dirty="0">
                <a:latin typeface="Times New Roman" panose="02020603050405020304" pitchFamily="18" charset="0"/>
                <a:ea typeface="바탕" panose="02030600000101010101" pitchFamily="18" charset="-127"/>
                <a:cs typeface="¹ÙÅÁ"/>
              </a:rPr>
              <a:t>1</a:t>
            </a:r>
            <a:r>
              <a:rPr lang="en-US" sz="1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¹ÙÅÁ"/>
              </a:rPr>
              <a:t>: Trends in breast cancer screening from 2009 to 2021 by types of screening, (A) – Overall; (B) – Organized; (C) – Opportunistic; </a:t>
            </a:r>
            <a:endParaRPr lang="en-US" sz="1100" dirty="0">
              <a:effectLst/>
              <a:latin typeface="¹ÙÅÁ"/>
              <a:ea typeface="바탕" panose="02030600000101010101" pitchFamily="18" charset="-127"/>
              <a:cs typeface="¹ÙÅÁ"/>
            </a:endParaRPr>
          </a:p>
        </p:txBody>
      </p:sp>
    </p:spTree>
    <p:extLst>
      <p:ext uri="{BB962C8B-B14F-4D97-AF65-F5344CB8AC3E}">
        <p14:creationId xmlns:p14="http://schemas.microsoft.com/office/powerpoint/2010/main" val="2913085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44</TotalTime>
  <Words>40</Words>
  <Application>Microsoft Office PowerPoint</Application>
  <PresentationFormat>와이드스크린</PresentationFormat>
  <Paragraphs>5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¹ÙÅÁ</vt:lpstr>
      <vt:lpstr>Arial</vt:lpstr>
      <vt:lpstr>Calibri</vt:lpstr>
      <vt:lpstr>Calibri Light</vt:lpstr>
      <vt:lpstr>Times New Roman</vt:lpstr>
      <vt:lpstr>Office Theme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 Yejin(17KC1504)</dc:creator>
  <cp:lastModifiedBy>Kui Son Choi</cp:lastModifiedBy>
  <cp:revision>28</cp:revision>
  <cp:lastPrinted>2023-05-30T11:31:34Z</cp:lastPrinted>
  <dcterms:created xsi:type="dcterms:W3CDTF">2023-05-25T08:34:37Z</dcterms:created>
  <dcterms:modified xsi:type="dcterms:W3CDTF">2025-03-28T04:26:34Z</dcterms:modified>
  <cp:contentStatus/>
</cp:coreProperties>
</file>